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D41F91-AA3F-4465-A04D-2EC3FBEC727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295842-C3CA-4F98-A2EC-14AEBFD14A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3166FB-253D-4B16-854C-35C127D2EC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5B5849-0D33-417E-AB59-15ABA54DB24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D802D8-0FB3-48EA-B2A7-45006C6165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6731FA-6082-4E87-A78F-BAEC59B607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E09B89-457F-449C-90C6-A171355492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4C5E53-83C2-4171-A912-FE9FA6A3AE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352BFA-34CB-4310-B375-1FA7CDF31D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493664-2761-446C-A3A2-12290F2830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04CE20-70F7-437A-B633-4FE89BE530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E4A99B-15AA-4493-B4E4-397E7EEACD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19775C-300E-4ADA-B2D5-E0DDD16619C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61960" y="1711440"/>
            <a:ext cx="2744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2435400" y="3036960"/>
            <a:ext cx="1996920" cy="1536480"/>
            <a:chOff x="2435400" y="3036960"/>
            <a:chExt cx="1996920" cy="1536480"/>
          </a:xfrm>
        </p:grpSpPr>
        <p:sp>
          <p:nvSpPr>
            <p:cNvPr id="43" name=""/>
            <p:cNvSpPr/>
            <p:nvPr/>
          </p:nvSpPr>
          <p:spPr>
            <a:xfrm>
              <a:off x="2435400" y="3036960"/>
              <a:ext cx="1996920" cy="153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784600" y="3313080"/>
              <a:ext cx="1423800" cy="95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886120" y="3595680"/>
              <a:ext cx="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886120" y="3595680"/>
              <a:ext cx="204840" cy="58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090960" y="3592440"/>
              <a:ext cx="0" cy="123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090960" y="3654360"/>
              <a:ext cx="203040" cy="311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294000" y="3965400"/>
              <a:ext cx="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294000" y="3965400"/>
              <a:ext cx="204840" cy="219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498840" y="4184640"/>
              <a:ext cx="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498840" y="4184640"/>
              <a:ext cx="20484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703680" y="4219560"/>
              <a:ext cx="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703680" y="4219560"/>
              <a:ext cx="203040" cy="11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906720" y="4230720"/>
              <a:ext cx="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906720" y="4230720"/>
              <a:ext cx="204840" cy="7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111560" y="4238640"/>
              <a:ext cx="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067200" y="3592440"/>
              <a:ext cx="47520" cy="360"/>
            </a:xfrm>
            <a:custGeom>
              <a:avLst/>
              <a:gdLst/>
              <a:ahLst/>
              <a:rect l="l" t="t" r="r" b="b"/>
              <a:pathLst>
                <a:path w="60" h="0">
                  <a:moveTo>
                    <a:pt x="0" y="0"/>
                  </a:moveTo>
                  <a:lnTo>
                    <a:pt x="6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067200" y="3716280"/>
              <a:ext cx="47520" cy="360"/>
            </a:xfrm>
            <a:custGeom>
              <a:avLst/>
              <a:gdLst/>
              <a:ahLst/>
              <a:rect l="l" t="t" r="r" b="b"/>
              <a:pathLst>
                <a:path w="60" h="0">
                  <a:moveTo>
                    <a:pt x="0" y="0"/>
                  </a:moveTo>
                  <a:lnTo>
                    <a:pt x="6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862360" y="357192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flipH="1" flipV="1">
              <a:off x="2862360" y="357192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flipV="1">
              <a:off x="2862360" y="357192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flipH="1">
              <a:off x="2862360" y="357192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067200" y="363060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flipH="1" flipV="1">
              <a:off x="3067200" y="363060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3067200" y="363060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flipH="1">
              <a:off x="3067200" y="363060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270240" y="394164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flipH="1" flipV="1">
              <a:off x="3270240" y="394164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flipV="1">
              <a:off x="3270240" y="394164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flipH="1">
              <a:off x="3270240" y="394164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475080" y="416088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flipH="1" flipV="1">
              <a:off x="3475080" y="416088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3475080" y="416088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 flipH="1">
              <a:off x="3475080" y="416088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679920" y="419580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flipH="1" flipV="1">
              <a:off x="3679920" y="419580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V="1">
              <a:off x="3679920" y="419580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H="1">
              <a:off x="3679920" y="419580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882960" y="420696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H="1" flipV="1">
              <a:off x="3882960" y="420696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flipV="1">
              <a:off x="3882960" y="420696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H="1">
              <a:off x="3882960" y="420696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087800" y="421488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flipH="1" flipV="1">
              <a:off x="4087800" y="421488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flipV="1">
              <a:off x="4087800" y="421488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flipH="1">
              <a:off x="4087800" y="4214880"/>
              <a:ext cx="47520" cy="47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886120" y="4189320"/>
              <a:ext cx="0" cy="52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flipV="1">
              <a:off x="2886120" y="4179600"/>
              <a:ext cx="20484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090960" y="4179960"/>
              <a:ext cx="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flipV="1">
              <a:off x="3090960" y="3534840"/>
              <a:ext cx="203040" cy="644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3294000" y="3416400"/>
              <a:ext cx="0" cy="237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flipV="1">
              <a:off x="3294000" y="3468240"/>
              <a:ext cx="204840" cy="66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498840" y="3468600"/>
              <a:ext cx="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498840" y="3468600"/>
              <a:ext cx="204840" cy="517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703680" y="3946320"/>
              <a:ext cx="0" cy="77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703680" y="3986280"/>
              <a:ext cx="203040" cy="247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906720" y="4233960"/>
              <a:ext cx="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3906720" y="4233960"/>
              <a:ext cx="2048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4111560" y="4235400"/>
              <a:ext cx="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862360" y="4189320"/>
              <a:ext cx="47520" cy="360"/>
            </a:xfrm>
            <a:custGeom>
              <a:avLst/>
              <a:gdLst/>
              <a:ahLst/>
              <a:rect l="l" t="t" r="r" b="b"/>
              <a:pathLst>
                <a:path w="60" h="0">
                  <a:moveTo>
                    <a:pt x="0" y="0"/>
                  </a:moveTo>
                  <a:lnTo>
                    <a:pt x="6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862360" y="4241880"/>
              <a:ext cx="47520" cy="360"/>
            </a:xfrm>
            <a:custGeom>
              <a:avLst/>
              <a:gdLst/>
              <a:ahLst/>
              <a:rect l="l" t="t" r="r" b="b"/>
              <a:pathLst>
                <a:path w="60" h="0">
                  <a:moveTo>
                    <a:pt x="0" y="0"/>
                  </a:moveTo>
                  <a:lnTo>
                    <a:pt x="6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3270240" y="3416400"/>
              <a:ext cx="47520" cy="360"/>
            </a:xfrm>
            <a:custGeom>
              <a:avLst/>
              <a:gdLst/>
              <a:ahLst/>
              <a:rect l="l" t="t" r="r" b="b"/>
              <a:pathLst>
                <a:path w="60" h="0">
                  <a:moveTo>
                    <a:pt x="0" y="0"/>
                  </a:moveTo>
                  <a:lnTo>
                    <a:pt x="6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3270240" y="3654360"/>
              <a:ext cx="47520" cy="360"/>
            </a:xfrm>
            <a:custGeom>
              <a:avLst/>
              <a:gdLst/>
              <a:ahLst/>
              <a:rect l="l" t="t" r="r" b="b"/>
              <a:pathLst>
                <a:path w="60" h="0">
                  <a:moveTo>
                    <a:pt x="0" y="0"/>
                  </a:moveTo>
                  <a:lnTo>
                    <a:pt x="6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3679920" y="3946320"/>
              <a:ext cx="47520" cy="360"/>
            </a:xfrm>
            <a:custGeom>
              <a:avLst/>
              <a:gdLst/>
              <a:ahLst/>
              <a:rect l="l" t="t" r="r" b="b"/>
              <a:pathLst>
                <a:path w="60" h="0">
                  <a:moveTo>
                    <a:pt x="0" y="0"/>
                  </a:moveTo>
                  <a:lnTo>
                    <a:pt x="6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3679920" y="4024080"/>
              <a:ext cx="47520" cy="360"/>
            </a:xfrm>
            <a:custGeom>
              <a:avLst/>
              <a:gdLst/>
              <a:ahLst/>
              <a:rect l="l" t="t" r="r" b="b"/>
              <a:pathLst>
                <a:path w="60" h="0">
                  <a:moveTo>
                    <a:pt x="0" y="0"/>
                  </a:moveTo>
                  <a:lnTo>
                    <a:pt x="60" y="0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2862360" y="4192560"/>
              <a:ext cx="44280" cy="4284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3067200" y="4155840"/>
              <a:ext cx="42840" cy="4284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3270240" y="3511440"/>
              <a:ext cx="44640" cy="4464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3475080" y="3444840"/>
              <a:ext cx="44280" cy="4284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3679920" y="3962160"/>
              <a:ext cx="42840" cy="4320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840" bIns="-15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3882960" y="4209840"/>
              <a:ext cx="44640" cy="4284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087800" y="4211640"/>
              <a:ext cx="42840" cy="4284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2784600" y="4267080"/>
              <a:ext cx="14284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2886120" y="4267080"/>
              <a:ext cx="0" cy="27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2857680" y="42861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3090960" y="4267080"/>
              <a:ext cx="0" cy="27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3060720" y="42861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3294000" y="4267080"/>
              <a:ext cx="0" cy="27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265560" y="42861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3498840" y="4267080"/>
              <a:ext cx="0" cy="27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3470400" y="42861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3703680" y="4267080"/>
              <a:ext cx="0" cy="27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3652920" y="42861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3906720" y="4267080"/>
              <a:ext cx="0" cy="27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3855960" y="42861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4111560" y="4267080"/>
              <a:ext cx="0" cy="27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4060800" y="42861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 flipV="1">
              <a:off x="2784600" y="3313080"/>
              <a:ext cx="0" cy="954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 flipH="1">
              <a:off x="2757240" y="4267080"/>
              <a:ext cx="27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2678040" y="42116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 flipH="1">
              <a:off x="2757240" y="4194000"/>
              <a:ext cx="27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flipH="1">
              <a:off x="2757240" y="4120920"/>
              <a:ext cx="27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2637000" y="40654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flipH="1">
              <a:off x="2757240" y="4048200"/>
              <a:ext cx="27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 flipH="1">
              <a:off x="2757240" y="3973320"/>
              <a:ext cx="27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2637000" y="39178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 flipH="1">
              <a:off x="2757240" y="3900240"/>
              <a:ext cx="27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flipH="1">
              <a:off x="2757240" y="3827520"/>
              <a:ext cx="27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2637000" y="3771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flipH="1">
              <a:off x="2757240" y="3752640"/>
              <a:ext cx="27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 flipH="1">
              <a:off x="2757240" y="3679920"/>
              <a:ext cx="27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2637000" y="36241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 flipH="1">
              <a:off x="2757240" y="3606840"/>
              <a:ext cx="27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flipH="1">
              <a:off x="2757240" y="3533760"/>
              <a:ext cx="27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2637000" y="34779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flipH="1">
              <a:off x="2757240" y="3460680"/>
              <a:ext cx="27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 flipH="1">
              <a:off x="2757240" y="3387600"/>
              <a:ext cx="27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2637000" y="33321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 flipH="1">
              <a:off x="2757240" y="3314520"/>
              <a:ext cx="27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3969000" y="3340080"/>
              <a:ext cx="183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RSV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3811680" y="3392280"/>
              <a:ext cx="141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3857760" y="3368520"/>
              <a:ext cx="47520" cy="47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flipH="1" flipV="1">
              <a:off x="3857760" y="3368160"/>
              <a:ext cx="47520" cy="47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 flipV="1">
              <a:off x="3857760" y="3368160"/>
              <a:ext cx="47520" cy="47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flipH="1">
              <a:off x="3857760" y="3368520"/>
              <a:ext cx="47520" cy="47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3970080" y="3449520"/>
              <a:ext cx="192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PV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3816360" y="3492360"/>
              <a:ext cx="141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3862440" y="3468600"/>
              <a:ext cx="44280" cy="42840"/>
            </a:xfrm>
            <a:prstGeom prst="ellipse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3071160" y="4386240"/>
              <a:ext cx="854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days post-infec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 rot="16200000">
              <a:off x="2285280" y="3768840"/>
              <a:ext cx="49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% NK cell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2" name=""/>
          <p:cNvSpPr/>
          <p:nvPr/>
        </p:nvSpPr>
        <p:spPr>
          <a:xfrm>
            <a:off x="477720" y="4678200"/>
            <a:ext cx="5934240" cy="143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Supplementary Fig. 1.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NK cell responses in PVM- compared to hRSV-infected mice. BALB/c mice were infecte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i.n.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with approximately 25 pfu PVM or 5x10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6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pfu hRSV and sacrificed at the indicated days p.i. NK cells (TCR</a:t>
            </a:r>
            <a:r>
              <a:rPr b="0" lang="el-GR" sz="11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-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DX5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) are shown as percentage of total lymphocytes as determined by flowcytometry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28T10:00:26Z</dcterms:created>
  <dc:creator>Sijts102</dc:creator>
  <dc:description/>
  <dc:language>en-US</dc:language>
  <cp:lastModifiedBy>Sijts102</cp:lastModifiedBy>
  <dcterms:modified xsi:type="dcterms:W3CDTF">2012-07-04T08:01:05Z</dcterms:modified>
  <cp:revision>21</cp:revision>
  <dc:subject/>
  <dc:title>Slide 1</dc:title>
</cp:coreProperties>
</file>